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2AB893B-7B70-428E-8D16-ADAD9E56E13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165A349-EB1E-4B01-86BA-A52ABF35F78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343C035-5134-4E12-A470-CCCA267D5CC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8F3FD34-BB9C-4166-A74B-E13DEF6A6F5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FB35155-B6EA-44BE-B1F2-DA605356CA5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DBD51FD-D35C-420B-9410-8A02527E4B7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5AA5962-6A70-4369-95E4-B3877151D71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16720F9-DA49-4515-96BA-42B54D21C29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D1D2DEF-24D8-464D-AA7C-A3897100706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F039D0C-1007-41C3-AE8D-A5469B2F924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6FFF442-92CF-4060-99D1-C2CE74E1618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2BA92E2-0CDE-4427-89C3-A868470F5A2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6282907-54DA-4835-A740-26ADF5C1E5C2}"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1"/>
          <p:cNvGrpSpPr/>
          <p:nvPr/>
        </p:nvGrpSpPr>
        <p:grpSpPr>
          <a:xfrm>
            <a:off x="473040" y="260280"/>
            <a:ext cx="6016680" cy="5073840"/>
            <a:chOff x="473040" y="260280"/>
            <a:chExt cx="6016680" cy="5073840"/>
          </a:xfrm>
        </p:grpSpPr>
        <p:pic>
          <p:nvPicPr>
            <p:cNvPr id="42" name="Picture 3" descr=""/>
            <p:cNvPicPr/>
            <p:nvPr/>
          </p:nvPicPr>
          <p:blipFill>
            <a:blip r:embed="rId1"/>
            <a:srcRect l="9172" t="0" r="0" b="0"/>
            <a:stretch/>
          </p:blipFill>
          <p:spPr>
            <a:xfrm>
              <a:off x="473040" y="310680"/>
              <a:ext cx="6016680" cy="5023440"/>
            </a:xfrm>
            <a:prstGeom prst="rect">
              <a:avLst/>
            </a:prstGeom>
            <a:ln w="0">
              <a:noFill/>
            </a:ln>
          </p:spPr>
        </p:pic>
        <p:sp>
          <p:nvSpPr>
            <p:cNvPr id="43" name="Rounded Rectangle 3"/>
            <p:cNvSpPr/>
            <p:nvPr/>
          </p:nvSpPr>
          <p:spPr>
            <a:xfrm>
              <a:off x="473040" y="260280"/>
              <a:ext cx="6016680" cy="4905720"/>
            </a:xfrm>
            <a:prstGeom prst="roundRect">
              <a:avLst>
                <a:gd name="adj" fmla="val 6398"/>
              </a:avLst>
            </a:prstGeom>
            <a:noFill/>
            <a:ln w="648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
        <p:nvSpPr>
          <p:cNvPr id="44" name="Rectangle 4"/>
          <p:cNvSpPr/>
          <p:nvPr/>
        </p:nvSpPr>
        <p:spPr>
          <a:xfrm>
            <a:off x="609480" y="5562720"/>
            <a:ext cx="5765760" cy="2402640"/>
          </a:xfrm>
          <a:prstGeom prst="rect">
            <a:avLst/>
          </a:prstGeom>
          <a:noFill/>
          <a:ln w="0">
            <a:noFill/>
          </a:ln>
        </p:spPr>
        <p:style>
          <a:lnRef idx="0"/>
          <a:fillRef idx="0"/>
          <a:effectRef idx="0"/>
          <a:fontRef idx="minor"/>
        </p:style>
        <p:txBody>
          <a:bodyPr lIns="90000" rIns="90000" tIns="46800" bIns="46800" anchor="t">
            <a:spAutoFit/>
          </a:bodyPr>
          <a:p>
            <a:pPr algn="just">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ea typeface="Calibri"/>
              </a:rPr>
              <a:t>Figure S4.</a:t>
            </a:r>
            <a:r>
              <a:rPr b="0" lang="en-IN" sz="1200" spc="-1" strike="noStrike">
                <a:solidFill>
                  <a:srgbClr val="000000"/>
                </a:solidFill>
                <a:latin typeface="Times New Roman"/>
                <a:ea typeface="Calibri"/>
              </a:rPr>
              <a:t> Nucleotide sequence of </a:t>
            </a:r>
            <a:r>
              <a:rPr b="0" i="1" lang="en-IN" sz="1200" spc="-1" strike="noStrike">
                <a:solidFill>
                  <a:srgbClr val="000000"/>
                </a:solidFill>
                <a:latin typeface="Times New Roman"/>
                <a:ea typeface="Calibri"/>
              </a:rPr>
              <a:t>SbSLSP</a:t>
            </a:r>
            <a:r>
              <a:rPr b="0" lang="en-IN" sz="1200" spc="-1" strike="noStrike">
                <a:solidFill>
                  <a:srgbClr val="000000"/>
                </a:solidFill>
                <a:latin typeface="Times New Roman"/>
                <a:ea typeface="Calibri"/>
              </a:rPr>
              <a:t> putative promoter sequence. The length of the promoter sequence is denoted by negative numerals upstream of translation start site ATG. Different abiotic stress responsive </a:t>
            </a:r>
            <a:r>
              <a:rPr b="0" i="1" lang="en-IN" sz="1200" spc="-1" strike="noStrike">
                <a:solidFill>
                  <a:srgbClr val="000000"/>
                </a:solidFill>
                <a:latin typeface="Times New Roman"/>
                <a:ea typeface="Calibri"/>
              </a:rPr>
              <a:t>cis</a:t>
            </a:r>
            <a:r>
              <a:rPr b="0" lang="en-IN" sz="1200" spc="-1" strike="noStrike">
                <a:solidFill>
                  <a:srgbClr val="000000"/>
                </a:solidFill>
                <a:latin typeface="Times New Roman"/>
                <a:ea typeface="Calibri"/>
              </a:rPr>
              <a:t>-regulatory motifs are shaded with colours. Nearest TATA box is predicted at -216bp and denoted with underlined bold letters. One of the 16 identified anaerobically induced motif </a:t>
            </a:r>
            <a:r>
              <a:rPr b="0" lang="en-IN" sz="1200" spc="-1" strike="noStrike">
                <a:solidFill>
                  <a:srgbClr val="000000"/>
                </a:solidFill>
                <a:latin typeface="Times New Roman"/>
                <a:ea typeface="Arial Unicode MS"/>
              </a:rPr>
              <a:t>ANAERO1CONSENSUS shaded with light green colour, defence related protein binding site shaded with orange colour, consensus sequence of MYC binding sequence is shaded with grey colour, MYB binding sequence is shaded with sky blue colour, copper and oxygen responsive motif is shaded with copper colour, heat responsive CAAT box are shaded with dark green colour, salinity stress responsive GT-1 element shaded with red colour, cold, drought and ABA responsive motif if shaded with pink colour, cold responsive LTRE-1 element is shaded with maroon colour.</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8-16T00:00:00Z</dcterms:created>
  <dc:creator>avinashstud1</dc:creator>
  <dc:description/>
  <dc:language>en-US</dc:language>
  <cp:lastModifiedBy>VIVEKANAND</cp:lastModifiedBy>
  <dcterms:modified xsi:type="dcterms:W3CDTF">2016-04-23T07:45:35Z</dcterms:modified>
  <cp:revision>7</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DocumentId">
    <vt:lpwstr>Presentation 4.PPT</vt:lpwstr>
  </property>
  <property fmtid="{D5CDD505-2E9C-101B-9397-08002B2CF9AE}" pid="3" name="DocumentType">
    <vt:lpwstr>Presentation</vt:lpwstr>
  </property>
  <property fmtid="{D5CDD505-2E9C-101B-9397-08002B2CF9AE}" pid="4" name="FileFormat">
    <vt:lpwstr>PPT</vt:lpwstr>
  </property>
  <property fmtid="{D5CDD505-2E9C-101B-9397-08002B2CF9AE}" pid="5" name="TitleName">
    <vt:lpwstr>Presentation 4.PPT</vt:lpwstr>
  </property>
</Properties>
</file>